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3" r:id="rId3"/>
    <p:sldId id="260" r:id="rId4"/>
    <p:sldId id="270" r:id="rId5"/>
    <p:sldId id="262" r:id="rId6"/>
    <p:sldId id="27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2" userDrawn="1">
          <p15:clr>
            <a:srgbClr val="A4A3A4"/>
          </p15:clr>
        </p15:guide>
        <p15:guide id="2" pos="72" userDrawn="1">
          <p15:clr>
            <a:srgbClr val="A4A3A4"/>
          </p15:clr>
        </p15:guide>
        <p15:guide id="3" pos="751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vinash Mishra" initials="AM" lastIdx="1" clrIdx="0">
    <p:extLst>
      <p:ext uri="{19B8F6BF-5375-455C-9EA6-DF929625EA0E}">
        <p15:presenceInfo xmlns:p15="http://schemas.microsoft.com/office/powerpoint/2012/main" userId="90f82dc741063489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125" autoAdjust="0"/>
    <p:restoredTop sz="94660"/>
  </p:normalViewPr>
  <p:slideViewPr>
    <p:cSldViewPr showGuides="1">
      <p:cViewPr varScale="1">
        <p:scale>
          <a:sx n="109" d="100"/>
          <a:sy n="109" d="100"/>
        </p:scale>
        <p:origin x="870" y="84"/>
      </p:cViewPr>
      <p:guideLst>
        <p:guide orient="horz" pos="72"/>
        <p:guide pos="72"/>
        <p:guide pos="751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8100" cy="381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MS%20In%20Progress\Bhakti\Acrosiphonia\DATA\Results%20of%20nbt%20nd%20rt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9790174533268088E-2"/>
          <c:y val="2.3809523809523808E-2"/>
          <c:w val="0.91407071174926668"/>
          <c:h val="0.8451781027371578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BIOCHEMICAL!$C$36</c:f>
              <c:strCache>
                <c:ptCount val="1"/>
                <c:pt idx="0">
                  <c:v>20 (10) µg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IOCHEMICAL!$C$45:$C$47</c:f>
                <c:numCache>
                  <c:formatCode>General</c:formatCode>
                  <c:ptCount val="3"/>
                  <c:pt idx="0">
                    <c:v>8.3612454980438386E-2</c:v>
                  </c:pt>
                  <c:pt idx="1">
                    <c:v>1.1091722639478097</c:v>
                  </c:pt>
                  <c:pt idx="2">
                    <c:v>0.71185445455219853</c:v>
                  </c:pt>
                </c:numCache>
              </c:numRef>
            </c:plus>
            <c:minus>
              <c:numRef>
                <c:f>BIOCHEMICAL!$C$45:$C$47</c:f>
                <c:numCache>
                  <c:formatCode>General</c:formatCode>
                  <c:ptCount val="3"/>
                  <c:pt idx="0">
                    <c:v>8.3612454980438386E-2</c:v>
                  </c:pt>
                  <c:pt idx="1">
                    <c:v>1.1091722639478097</c:v>
                  </c:pt>
                  <c:pt idx="2">
                    <c:v>0.71185445455219853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BIOCHEMICAL!$B$37:$B$39</c:f>
              <c:strCache>
                <c:ptCount val="3"/>
                <c:pt idx="0">
                  <c:v>Total antioxidant (ABTS inhibition)</c:v>
                </c:pt>
                <c:pt idx="1">
                  <c:v>Radical scavenging (DPPH inhibition)</c:v>
                </c:pt>
                <c:pt idx="2">
                  <c:v>Reducing capacity</c:v>
                </c:pt>
              </c:strCache>
            </c:strRef>
          </c:cat>
          <c:val>
            <c:numRef>
              <c:f>BIOCHEMICAL!$C$37:$C$39</c:f>
              <c:numCache>
                <c:formatCode>General</c:formatCode>
                <c:ptCount val="3"/>
                <c:pt idx="0">
                  <c:v>33.243206591906002</c:v>
                </c:pt>
                <c:pt idx="1">
                  <c:v>49.128666666666668</c:v>
                </c:pt>
                <c:pt idx="2">
                  <c:v>47.4117503729705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982-44CF-B839-2842E4D2D3F9}"/>
            </c:ext>
          </c:extLst>
        </c:ser>
        <c:ser>
          <c:idx val="1"/>
          <c:order val="1"/>
          <c:tx>
            <c:strRef>
              <c:f>BIOCHEMICAL!$D$36</c:f>
              <c:strCache>
                <c:ptCount val="1"/>
                <c:pt idx="0">
                  <c:v>40 (20) µg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IOCHEMICAL!$D$45:$D$47</c:f>
                <c:numCache>
                  <c:formatCode>General</c:formatCode>
                  <c:ptCount val="3"/>
                  <c:pt idx="0">
                    <c:v>0.41681234456987365</c:v>
                  </c:pt>
                  <c:pt idx="1">
                    <c:v>1.0957860699566844</c:v>
                  </c:pt>
                  <c:pt idx="2">
                    <c:v>0.61330071799383223</c:v>
                  </c:pt>
                </c:numCache>
              </c:numRef>
            </c:plus>
            <c:minus>
              <c:numRef>
                <c:f>BIOCHEMICAL!$D$45:$D$47</c:f>
                <c:numCache>
                  <c:formatCode>General</c:formatCode>
                  <c:ptCount val="3"/>
                  <c:pt idx="0">
                    <c:v>0.41681234456987365</c:v>
                  </c:pt>
                  <c:pt idx="1">
                    <c:v>1.0957860699566844</c:v>
                  </c:pt>
                  <c:pt idx="2">
                    <c:v>0.61330071799383223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BIOCHEMICAL!$B$37:$B$39</c:f>
              <c:strCache>
                <c:ptCount val="3"/>
                <c:pt idx="0">
                  <c:v>Total antioxidant (ABTS inhibition)</c:v>
                </c:pt>
                <c:pt idx="1">
                  <c:v>Radical scavenging (DPPH inhibition)</c:v>
                </c:pt>
                <c:pt idx="2">
                  <c:v>Reducing capacity</c:v>
                </c:pt>
              </c:strCache>
            </c:strRef>
          </c:cat>
          <c:val>
            <c:numRef>
              <c:f>BIOCHEMICAL!$D$37:$D$39</c:f>
              <c:numCache>
                <c:formatCode>General</c:formatCode>
                <c:ptCount val="3"/>
                <c:pt idx="0">
                  <c:v>54.4951218014277</c:v>
                </c:pt>
                <c:pt idx="1">
                  <c:v>52.413333333333334</c:v>
                </c:pt>
                <c:pt idx="2">
                  <c:v>76.79542472994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982-44CF-B839-2842E4D2D3F9}"/>
            </c:ext>
          </c:extLst>
        </c:ser>
        <c:ser>
          <c:idx val="2"/>
          <c:order val="2"/>
          <c:tx>
            <c:strRef>
              <c:f>BIOCHEMICAL!$E$36</c:f>
              <c:strCache>
                <c:ptCount val="1"/>
                <c:pt idx="0">
                  <c:v>60 (30) µ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IOCHEMICAL!$E$45:$E$47</c:f>
                <c:numCache>
                  <c:formatCode>General</c:formatCode>
                  <c:ptCount val="3"/>
                  <c:pt idx="0">
                    <c:v>0.15388080098131454</c:v>
                  </c:pt>
                  <c:pt idx="1">
                    <c:v>1.0824269028437918</c:v>
                  </c:pt>
                  <c:pt idx="2">
                    <c:v>0.43886118490645531</c:v>
                  </c:pt>
                </c:numCache>
              </c:numRef>
            </c:plus>
            <c:minus>
              <c:numRef>
                <c:f>BIOCHEMICAL!$E$45:$E$47</c:f>
                <c:numCache>
                  <c:formatCode>General</c:formatCode>
                  <c:ptCount val="3"/>
                  <c:pt idx="0">
                    <c:v>0.15388080098131454</c:v>
                  </c:pt>
                  <c:pt idx="1">
                    <c:v>1.0824269028437918</c:v>
                  </c:pt>
                  <c:pt idx="2">
                    <c:v>0.43886118490645531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BIOCHEMICAL!$B$37:$B$39</c:f>
              <c:strCache>
                <c:ptCount val="3"/>
                <c:pt idx="0">
                  <c:v>Total antioxidant (ABTS inhibition)</c:v>
                </c:pt>
                <c:pt idx="1">
                  <c:v>Radical scavenging (DPPH inhibition)</c:v>
                </c:pt>
                <c:pt idx="2">
                  <c:v>Reducing capacity</c:v>
                </c:pt>
              </c:strCache>
            </c:strRef>
          </c:cat>
          <c:val>
            <c:numRef>
              <c:f>BIOCHEMICAL!$E$37:$E$39</c:f>
              <c:numCache>
                <c:formatCode>General</c:formatCode>
                <c:ptCount val="3"/>
                <c:pt idx="0">
                  <c:v>68.721377377365869</c:v>
                </c:pt>
                <c:pt idx="1">
                  <c:v>55.698000000000008</c:v>
                </c:pt>
                <c:pt idx="2">
                  <c:v>78.3740007374876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982-44CF-B839-2842E4D2D3F9}"/>
            </c:ext>
          </c:extLst>
        </c:ser>
        <c:ser>
          <c:idx val="3"/>
          <c:order val="3"/>
          <c:tx>
            <c:strRef>
              <c:f>BIOCHEMICAL!$F$36</c:f>
              <c:strCache>
                <c:ptCount val="1"/>
                <c:pt idx="0">
                  <c:v>80 (40) µg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IOCHEMICAL!$F$45:$F$47</c:f>
                <c:numCache>
                  <c:formatCode>General</c:formatCode>
                  <c:ptCount val="3"/>
                  <c:pt idx="0">
                    <c:v>0.62728360239933212</c:v>
                  </c:pt>
                  <c:pt idx="1">
                    <c:v>1.0690957757739847</c:v>
                  </c:pt>
                  <c:pt idx="2">
                    <c:v>0.34263655011914712</c:v>
                  </c:pt>
                </c:numCache>
              </c:numRef>
            </c:plus>
            <c:minus>
              <c:numRef>
                <c:f>BIOCHEMICAL!$F$45:$F$47</c:f>
                <c:numCache>
                  <c:formatCode>General</c:formatCode>
                  <c:ptCount val="3"/>
                  <c:pt idx="0">
                    <c:v>0.62728360239933212</c:v>
                  </c:pt>
                  <c:pt idx="1">
                    <c:v>1.0690957757739847</c:v>
                  </c:pt>
                  <c:pt idx="2">
                    <c:v>0.3426365501191471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BIOCHEMICAL!$B$37:$B$39</c:f>
              <c:strCache>
                <c:ptCount val="3"/>
                <c:pt idx="0">
                  <c:v>Total antioxidant (ABTS inhibition)</c:v>
                </c:pt>
                <c:pt idx="1">
                  <c:v>Radical scavenging (DPPH inhibition)</c:v>
                </c:pt>
                <c:pt idx="2">
                  <c:v>Reducing capacity</c:v>
                </c:pt>
              </c:strCache>
            </c:strRef>
          </c:cat>
          <c:val>
            <c:numRef>
              <c:f>BIOCHEMICAL!$F$37:$F$39</c:f>
              <c:numCache>
                <c:formatCode>General</c:formatCode>
                <c:ptCount val="3"/>
                <c:pt idx="0">
                  <c:v>78.182845543532139</c:v>
                </c:pt>
                <c:pt idx="1">
                  <c:v>58.982666666666667</c:v>
                </c:pt>
                <c:pt idx="2">
                  <c:v>82.1591095194904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982-44CF-B839-2842E4D2D3F9}"/>
            </c:ext>
          </c:extLst>
        </c:ser>
        <c:ser>
          <c:idx val="4"/>
          <c:order val="4"/>
          <c:tx>
            <c:strRef>
              <c:f>BIOCHEMICAL!$G$36</c:f>
              <c:strCache>
                <c:ptCount val="1"/>
                <c:pt idx="0">
                  <c:v>100 (50) µg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IOCHEMICAL!$G$45:$G$47</c:f>
                <c:numCache>
                  <c:formatCode>General</c:formatCode>
                  <c:ptCount val="3"/>
                  <c:pt idx="0">
                    <c:v>0.3723826811306909</c:v>
                  </c:pt>
                  <c:pt idx="1">
                    <c:v>1.3308836768045924</c:v>
                  </c:pt>
                  <c:pt idx="2">
                    <c:v>0.48378204819632331</c:v>
                  </c:pt>
                </c:numCache>
              </c:numRef>
            </c:plus>
            <c:minus>
              <c:numRef>
                <c:f>BIOCHEMICAL!$G$45:$G$47</c:f>
                <c:numCache>
                  <c:formatCode>General</c:formatCode>
                  <c:ptCount val="3"/>
                  <c:pt idx="0">
                    <c:v>0.3723826811306909</c:v>
                  </c:pt>
                  <c:pt idx="1">
                    <c:v>1.3308836768045924</c:v>
                  </c:pt>
                  <c:pt idx="2">
                    <c:v>0.48378204819632331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BIOCHEMICAL!$B$37:$B$39</c:f>
              <c:strCache>
                <c:ptCount val="3"/>
                <c:pt idx="0">
                  <c:v>Total antioxidant (ABTS inhibition)</c:v>
                </c:pt>
                <c:pt idx="1">
                  <c:v>Radical scavenging (DPPH inhibition)</c:v>
                </c:pt>
                <c:pt idx="2">
                  <c:v>Reducing capacity</c:v>
                </c:pt>
              </c:strCache>
            </c:strRef>
          </c:cat>
          <c:val>
            <c:numRef>
              <c:f>BIOCHEMICAL!$G$37:$G$39</c:f>
              <c:numCache>
                <c:formatCode>General</c:formatCode>
                <c:ptCount val="3"/>
                <c:pt idx="0">
                  <c:v>84.671756081700707</c:v>
                </c:pt>
                <c:pt idx="1">
                  <c:v>67.033192569061271</c:v>
                </c:pt>
                <c:pt idx="2">
                  <c:v>78.1293582464313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982-44CF-B839-2842E4D2D3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8147503"/>
        <c:axId val="298150415"/>
      </c:barChart>
      <c:catAx>
        <c:axId val="298147503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1200" b="1"/>
                  <a:t>Biochemical activities</a:t>
                </a:r>
              </a:p>
            </c:rich>
          </c:tx>
          <c:layout>
            <c:manualLayout>
              <c:xMode val="edge"/>
              <c:yMode val="edge"/>
              <c:x val="0.41848956380452446"/>
              <c:y val="0.9255389951256093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98150415"/>
        <c:crosses val="autoZero"/>
        <c:auto val="1"/>
        <c:lblAlgn val="ctr"/>
        <c:lblOffset val="0"/>
        <c:noMultiLvlLbl val="0"/>
      </c:catAx>
      <c:valAx>
        <c:axId val="2981504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1200" b="1"/>
                  <a:t>Percent inhibition</a:t>
                </a:r>
              </a:p>
            </c:rich>
          </c:tx>
          <c:layout>
            <c:manualLayout>
              <c:xMode val="edge"/>
              <c:yMode val="edge"/>
              <c:x val="3.968253968253968E-3"/>
              <c:y val="0.2565307461567303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9814750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8.8263084761463662E-2"/>
          <c:y val="1.2046931633545806E-2"/>
          <c:w val="0.11770809898762655"/>
          <c:h val="0.226048306461692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8.136404824396952E-2"/>
          <c:y val="4.1815398075240588E-2"/>
          <c:w val="0.91069944381952261"/>
          <c:h val="0.8473047119110110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BIOCHEMICAL!$B$37</c:f>
              <c:strCache>
                <c:ptCount val="1"/>
                <c:pt idx="0">
                  <c:v>Total antioxidant (ABTS inhibition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IOCHEMICAL!$C$45:$G$45</c:f>
                <c:numCache>
                  <c:formatCode>General</c:formatCode>
                  <c:ptCount val="5"/>
                  <c:pt idx="0">
                    <c:v>8.3612454980438386E-2</c:v>
                  </c:pt>
                  <c:pt idx="1">
                    <c:v>0.41681234456987365</c:v>
                  </c:pt>
                  <c:pt idx="2">
                    <c:v>0.15388080098131454</c:v>
                  </c:pt>
                  <c:pt idx="3">
                    <c:v>0.62728360239933212</c:v>
                  </c:pt>
                  <c:pt idx="4">
                    <c:v>0.3723826811306909</c:v>
                  </c:pt>
                </c:numCache>
              </c:numRef>
            </c:plus>
            <c:minus>
              <c:numRef>
                <c:f>BIOCHEMICAL!$C$45:$G$45</c:f>
                <c:numCache>
                  <c:formatCode>General</c:formatCode>
                  <c:ptCount val="5"/>
                  <c:pt idx="0">
                    <c:v>8.3612454980438386E-2</c:v>
                  </c:pt>
                  <c:pt idx="1">
                    <c:v>0.41681234456987365</c:v>
                  </c:pt>
                  <c:pt idx="2">
                    <c:v>0.15388080098131454</c:v>
                  </c:pt>
                  <c:pt idx="3">
                    <c:v>0.62728360239933212</c:v>
                  </c:pt>
                  <c:pt idx="4">
                    <c:v>0.3723826811306909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BIOCHEMICAL!$C$36:$G$36</c:f>
              <c:strCache>
                <c:ptCount val="5"/>
                <c:pt idx="0">
                  <c:v>20 (10) µg</c:v>
                </c:pt>
                <c:pt idx="1">
                  <c:v>40 (20) µg</c:v>
                </c:pt>
                <c:pt idx="2">
                  <c:v>60 (30) µg</c:v>
                </c:pt>
                <c:pt idx="3">
                  <c:v>80 (40) µg</c:v>
                </c:pt>
                <c:pt idx="4">
                  <c:v>100 (50) µg</c:v>
                </c:pt>
              </c:strCache>
            </c:strRef>
          </c:cat>
          <c:val>
            <c:numRef>
              <c:f>BIOCHEMICAL!$C$37:$G$37</c:f>
              <c:numCache>
                <c:formatCode>General</c:formatCode>
                <c:ptCount val="5"/>
                <c:pt idx="0">
                  <c:v>33.243206591906002</c:v>
                </c:pt>
                <c:pt idx="1">
                  <c:v>54.4951218014277</c:v>
                </c:pt>
                <c:pt idx="2">
                  <c:v>68.721377377365869</c:v>
                </c:pt>
                <c:pt idx="3">
                  <c:v>78.182845543532139</c:v>
                </c:pt>
                <c:pt idx="4">
                  <c:v>84.6717560817007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644-454D-B51A-A02841C70B6B}"/>
            </c:ext>
          </c:extLst>
        </c:ser>
        <c:ser>
          <c:idx val="1"/>
          <c:order val="1"/>
          <c:tx>
            <c:strRef>
              <c:f>BIOCHEMICAL!$B$38</c:f>
              <c:strCache>
                <c:ptCount val="1"/>
                <c:pt idx="0">
                  <c:v>Radical scavenging (DPPH inhibition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IOCHEMICAL!$C$46:$G$46</c:f>
                <c:numCache>
                  <c:formatCode>General</c:formatCode>
                  <c:ptCount val="5"/>
                  <c:pt idx="0">
                    <c:v>1.1091722639478097</c:v>
                  </c:pt>
                  <c:pt idx="1">
                    <c:v>1.0957860699566844</c:v>
                  </c:pt>
                  <c:pt idx="2">
                    <c:v>1.0824269028437918</c:v>
                  </c:pt>
                  <c:pt idx="3">
                    <c:v>1.0690957757739847</c:v>
                  </c:pt>
                  <c:pt idx="4">
                    <c:v>1.3308836768045924</c:v>
                  </c:pt>
                </c:numCache>
              </c:numRef>
            </c:plus>
            <c:minus>
              <c:numRef>
                <c:f>BIOCHEMICAL!$C$46:$G$46</c:f>
                <c:numCache>
                  <c:formatCode>General</c:formatCode>
                  <c:ptCount val="5"/>
                  <c:pt idx="0">
                    <c:v>1.1091722639478097</c:v>
                  </c:pt>
                  <c:pt idx="1">
                    <c:v>1.0957860699566844</c:v>
                  </c:pt>
                  <c:pt idx="2">
                    <c:v>1.0824269028437918</c:v>
                  </c:pt>
                  <c:pt idx="3">
                    <c:v>1.0690957757739847</c:v>
                  </c:pt>
                  <c:pt idx="4">
                    <c:v>1.3308836768045924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BIOCHEMICAL!$C$36:$G$36</c:f>
              <c:strCache>
                <c:ptCount val="5"/>
                <c:pt idx="0">
                  <c:v>20 (10) µg</c:v>
                </c:pt>
                <c:pt idx="1">
                  <c:v>40 (20) µg</c:v>
                </c:pt>
                <c:pt idx="2">
                  <c:v>60 (30) µg</c:v>
                </c:pt>
                <c:pt idx="3">
                  <c:v>80 (40) µg</c:v>
                </c:pt>
                <c:pt idx="4">
                  <c:v>100 (50) µg</c:v>
                </c:pt>
              </c:strCache>
            </c:strRef>
          </c:cat>
          <c:val>
            <c:numRef>
              <c:f>BIOCHEMICAL!$C$38:$G$38</c:f>
              <c:numCache>
                <c:formatCode>General</c:formatCode>
                <c:ptCount val="5"/>
                <c:pt idx="0">
                  <c:v>49.128666666666668</c:v>
                </c:pt>
                <c:pt idx="1">
                  <c:v>52.413333333333334</c:v>
                </c:pt>
                <c:pt idx="2">
                  <c:v>55.698000000000008</c:v>
                </c:pt>
                <c:pt idx="3">
                  <c:v>58.982666666666667</c:v>
                </c:pt>
                <c:pt idx="4">
                  <c:v>67.0331925690612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644-454D-B51A-A02841C70B6B}"/>
            </c:ext>
          </c:extLst>
        </c:ser>
        <c:ser>
          <c:idx val="2"/>
          <c:order val="2"/>
          <c:tx>
            <c:strRef>
              <c:f>BIOCHEMICAL!$B$39</c:f>
              <c:strCache>
                <c:ptCount val="1"/>
                <c:pt idx="0">
                  <c:v>Reducing capacity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IOCHEMICAL!$C$47:$G$47</c:f>
                <c:numCache>
                  <c:formatCode>General</c:formatCode>
                  <c:ptCount val="5"/>
                  <c:pt idx="0">
                    <c:v>0.71185445455219853</c:v>
                  </c:pt>
                  <c:pt idx="1">
                    <c:v>0.61330071799383223</c:v>
                  </c:pt>
                  <c:pt idx="2">
                    <c:v>0.43886118490645531</c:v>
                  </c:pt>
                  <c:pt idx="3">
                    <c:v>0.34263655011914712</c:v>
                  </c:pt>
                  <c:pt idx="4">
                    <c:v>0.48378204819632331</c:v>
                  </c:pt>
                </c:numCache>
              </c:numRef>
            </c:plus>
            <c:minus>
              <c:numRef>
                <c:f>BIOCHEMICAL!$C$47:$G$47</c:f>
                <c:numCache>
                  <c:formatCode>General</c:formatCode>
                  <c:ptCount val="5"/>
                  <c:pt idx="0">
                    <c:v>0.71185445455219853</c:v>
                  </c:pt>
                  <c:pt idx="1">
                    <c:v>0.61330071799383223</c:v>
                  </c:pt>
                  <c:pt idx="2">
                    <c:v>0.43886118490645531</c:v>
                  </c:pt>
                  <c:pt idx="3">
                    <c:v>0.34263655011914712</c:v>
                  </c:pt>
                  <c:pt idx="4">
                    <c:v>0.48378204819632331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BIOCHEMICAL!$C$36:$G$36</c:f>
              <c:strCache>
                <c:ptCount val="5"/>
                <c:pt idx="0">
                  <c:v>20 (10) µg</c:v>
                </c:pt>
                <c:pt idx="1">
                  <c:v>40 (20) µg</c:v>
                </c:pt>
                <c:pt idx="2">
                  <c:v>60 (30) µg</c:v>
                </c:pt>
                <c:pt idx="3">
                  <c:v>80 (40) µg</c:v>
                </c:pt>
                <c:pt idx="4">
                  <c:v>100 (50) µg</c:v>
                </c:pt>
              </c:strCache>
            </c:strRef>
          </c:cat>
          <c:val>
            <c:numRef>
              <c:f>BIOCHEMICAL!$C$39:$G$39</c:f>
              <c:numCache>
                <c:formatCode>General</c:formatCode>
                <c:ptCount val="5"/>
                <c:pt idx="0">
                  <c:v>47.411750372970538</c:v>
                </c:pt>
                <c:pt idx="1">
                  <c:v>76.79542472994666</c:v>
                </c:pt>
                <c:pt idx="2">
                  <c:v>78.374000737487691</c:v>
                </c:pt>
                <c:pt idx="3">
                  <c:v>82.159109519490428</c:v>
                </c:pt>
                <c:pt idx="4">
                  <c:v>78.1293582464313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644-454D-B51A-A02841C70B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15797391"/>
        <c:axId val="1615800303"/>
      </c:barChart>
      <c:catAx>
        <c:axId val="161579739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1200" b="1" dirty="0"/>
                  <a:t>Concentration (µg ml</a:t>
                </a:r>
                <a:r>
                  <a:rPr lang="en-IN" sz="1200" b="1" baseline="30000" dirty="0"/>
                  <a:t>‒1</a:t>
                </a:r>
                <a:r>
                  <a:rPr lang="en-IN" sz="1200" b="1" dirty="0"/>
                  <a:t>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800303"/>
        <c:crosses val="autoZero"/>
        <c:auto val="1"/>
        <c:lblAlgn val="ctr"/>
        <c:lblOffset val="0"/>
        <c:noMultiLvlLbl val="0"/>
      </c:catAx>
      <c:valAx>
        <c:axId val="161580030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1200" b="1" dirty="0"/>
                  <a:t>Percent inhibition</a:t>
                </a:r>
              </a:p>
            </c:rich>
          </c:tx>
          <c:layout>
            <c:manualLayout>
              <c:xMode val="edge"/>
              <c:yMode val="edge"/>
              <c:x val="0"/>
              <c:y val="0.2469756905386827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1579739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7.7777829241932994E-2"/>
          <c:y val="3.188820147481565E-2"/>
          <c:w val="0.91785714285714304"/>
          <c:h val="5.541338582677165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65556649168854"/>
          <c:y val="3.0764071157771945E-2"/>
          <c:w val="0.83677766841644796"/>
          <c:h val="0.8027890784485273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J$36:$K$36</c:f>
                <c:numCache>
                  <c:formatCode>General</c:formatCode>
                  <c:ptCount val="2"/>
                  <c:pt idx="0">
                    <c:v>1.0574958973346216</c:v>
                  </c:pt>
                  <c:pt idx="1">
                    <c:v>1.6162292535933425</c:v>
                  </c:pt>
                </c:numCache>
              </c:numRef>
            </c:plus>
            <c:minus>
              <c:numRef>
                <c:f>Sheet1!$J$36:$K$36</c:f>
                <c:numCache>
                  <c:formatCode>General</c:formatCode>
                  <c:ptCount val="2"/>
                  <c:pt idx="0">
                    <c:v>1.0574958973346216</c:v>
                  </c:pt>
                  <c:pt idx="1">
                    <c:v>1.61622925359334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H$35:$I$35</c:f>
              <c:strCache>
                <c:ptCount val="2"/>
                <c:pt idx="0">
                  <c:v>HeLa</c:v>
                </c:pt>
                <c:pt idx="1">
                  <c:v>Huh-7</c:v>
                </c:pt>
              </c:strCache>
            </c:strRef>
          </c:cat>
          <c:val>
            <c:numRef>
              <c:f>Sheet1!$H$36:$I$36</c:f>
              <c:numCache>
                <c:formatCode>0.00</c:formatCode>
                <c:ptCount val="2"/>
                <c:pt idx="0">
                  <c:v>41.053753584489989</c:v>
                </c:pt>
                <c:pt idx="1">
                  <c:v>40.757159355006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6B5-462C-96D2-8F0A70E656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27499759"/>
        <c:axId val="727498511"/>
      </c:barChart>
      <c:catAx>
        <c:axId val="72749975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b="1" dirty="0"/>
                  <a:t>Cell lines</a:t>
                </a:r>
              </a:p>
            </c:rich>
          </c:tx>
          <c:layout>
            <c:manualLayout>
              <c:xMode val="edge"/>
              <c:yMode val="edge"/>
              <c:x val="0.45117366579177604"/>
              <c:y val="0.9037037037037035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27498511"/>
        <c:crosses val="autoZero"/>
        <c:auto val="1"/>
        <c:lblAlgn val="ctr"/>
        <c:lblOffset val="0"/>
        <c:noMultiLvlLbl val="0"/>
      </c:catAx>
      <c:valAx>
        <c:axId val="727498511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b="1" dirty="0"/>
                  <a:t>Radical percent inhibition</a:t>
                </a:r>
              </a:p>
            </c:rich>
          </c:tx>
          <c:layout>
            <c:manualLayout>
              <c:xMode val="edge"/>
              <c:yMode val="edge"/>
              <c:x val="0"/>
              <c:y val="0.1168463837853601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27499759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96FB9-C806-4D97-972A-70D3DF5E975B}" type="datetimeFigureOut">
              <a:rPr lang="en-IN" smtClean="0"/>
              <a:t>21-04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925B8-27D9-4596-B044-B514AB4042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213346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96FB9-C806-4D97-972A-70D3DF5E975B}" type="datetimeFigureOut">
              <a:rPr lang="en-IN" smtClean="0"/>
              <a:t>21-04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925B8-27D9-4596-B044-B514AB4042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495496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96FB9-C806-4D97-972A-70D3DF5E975B}" type="datetimeFigureOut">
              <a:rPr lang="en-IN" smtClean="0"/>
              <a:t>21-04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925B8-27D9-4596-B044-B514AB4042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71332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96FB9-C806-4D97-972A-70D3DF5E975B}" type="datetimeFigureOut">
              <a:rPr lang="en-IN" smtClean="0"/>
              <a:t>21-04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925B8-27D9-4596-B044-B514AB4042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149313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96FB9-C806-4D97-972A-70D3DF5E975B}" type="datetimeFigureOut">
              <a:rPr lang="en-IN" smtClean="0"/>
              <a:t>21-04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925B8-27D9-4596-B044-B514AB4042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939392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96FB9-C806-4D97-972A-70D3DF5E975B}" type="datetimeFigureOut">
              <a:rPr lang="en-IN" smtClean="0"/>
              <a:t>21-04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925B8-27D9-4596-B044-B514AB4042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996144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96FB9-C806-4D97-972A-70D3DF5E975B}" type="datetimeFigureOut">
              <a:rPr lang="en-IN" smtClean="0"/>
              <a:t>21-04-20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925B8-27D9-4596-B044-B514AB4042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656064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96FB9-C806-4D97-972A-70D3DF5E975B}" type="datetimeFigureOut">
              <a:rPr lang="en-IN" smtClean="0"/>
              <a:t>21-04-20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925B8-27D9-4596-B044-B514AB4042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28438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96FB9-C806-4D97-972A-70D3DF5E975B}" type="datetimeFigureOut">
              <a:rPr lang="en-IN" smtClean="0"/>
              <a:t>21-04-20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925B8-27D9-4596-B044-B514AB4042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265136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96FB9-C806-4D97-972A-70D3DF5E975B}" type="datetimeFigureOut">
              <a:rPr lang="en-IN" smtClean="0"/>
              <a:t>21-04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925B8-27D9-4596-B044-B514AB4042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835915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96FB9-C806-4D97-972A-70D3DF5E975B}" type="datetimeFigureOut">
              <a:rPr lang="en-IN" smtClean="0"/>
              <a:t>21-04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925B8-27D9-4596-B044-B514AB4042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226686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B96FB9-C806-4D97-972A-70D3DF5E975B}" type="datetimeFigureOut">
              <a:rPr lang="en-IN" smtClean="0"/>
              <a:t>21-04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2925B8-27D9-4596-B044-B514AB4042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24861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55C6E501-88DC-4349-9D32-A51014823355}"/>
              </a:ext>
            </a:extLst>
          </p:cNvPr>
          <p:cNvGrpSpPr/>
          <p:nvPr/>
        </p:nvGrpSpPr>
        <p:grpSpPr>
          <a:xfrm>
            <a:off x="1409700" y="154055"/>
            <a:ext cx="6752178" cy="6551545"/>
            <a:chOff x="2582322" y="0"/>
            <a:chExt cx="6752178" cy="6551545"/>
          </a:xfrm>
        </p:grpSpPr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868A26CE-47FC-4A57-B459-C0FC4E9E92E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16879196"/>
                </p:ext>
              </p:extLst>
            </p:nvPr>
          </p:nvGraphicFramePr>
          <p:xfrm>
            <a:off x="2857500" y="114300"/>
            <a:ext cx="6477000" cy="3200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7" name="Chart 6">
              <a:extLst>
                <a:ext uri="{FF2B5EF4-FFF2-40B4-BE49-F238E27FC236}">
                  <a16:creationId xmlns:a16="http://schemas.microsoft.com/office/drawing/2014/main" id="{EA9EB088-C0FD-45EA-82C3-2D95B929DDD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10327229"/>
                </p:ext>
              </p:extLst>
            </p:nvPr>
          </p:nvGraphicFramePr>
          <p:xfrm>
            <a:off x="2857500" y="3351145"/>
            <a:ext cx="6477000" cy="3200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44F9F520-C80A-4557-97C6-09B1C5734917}"/>
                </a:ext>
              </a:extLst>
            </p:cNvPr>
            <p:cNvSpPr txBox="1"/>
            <p:nvPr/>
          </p:nvSpPr>
          <p:spPr>
            <a:xfrm>
              <a:off x="2582322" y="0"/>
              <a:ext cx="351378" cy="39703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  <a:p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  <a:p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489218F1-7E22-4242-9E25-C6D940A1765E}"/>
              </a:ext>
            </a:extLst>
          </p:cNvPr>
          <p:cNvSpPr txBox="1"/>
          <p:nvPr/>
        </p:nvSpPr>
        <p:spPr>
          <a:xfrm>
            <a:off x="8305800" y="4124373"/>
            <a:ext cx="3314700" cy="2462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  <a:tabLst>
                <a:tab pos="355600" algn="l"/>
                <a:tab pos="711200" algn="l"/>
                <a:tab pos="1066800" algn="l"/>
                <a:tab pos="1422400" algn="l"/>
                <a:tab pos="1778000" algn="l"/>
                <a:tab pos="2133600" algn="l"/>
                <a:tab pos="2489200" algn="l"/>
                <a:tab pos="2844800" algn="l"/>
                <a:tab pos="3200400" algn="l"/>
                <a:tab pos="3556000" algn="l"/>
                <a:tab pos="3911600" algn="l"/>
                <a:tab pos="4267200" algn="l"/>
              </a:tabLst>
            </a:pPr>
            <a:r>
              <a:rPr lang="en-US" sz="1400" b="1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igure S1:</a:t>
            </a:r>
            <a:r>
              <a:rPr lang="en-US" sz="140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iochemical activities of </a:t>
            </a:r>
            <a:r>
              <a:rPr lang="en-US" sz="1400" b="1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Acrosiphonia</a:t>
            </a:r>
            <a:r>
              <a:rPr lang="en-US" sz="14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400" b="1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orientalis</a:t>
            </a:r>
            <a:r>
              <a:rPr lang="en-US" sz="14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4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extract</a:t>
            </a:r>
            <a:r>
              <a:rPr lang="en-US" sz="14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.</a:t>
            </a:r>
            <a:r>
              <a:rPr lang="en-US" sz="14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IN" sz="14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Total antioxidant activity, scavenging activity, and reducing capacity of </a:t>
            </a:r>
            <a:r>
              <a:rPr lang="en-US" sz="14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Acrosiphonia</a:t>
            </a:r>
            <a:r>
              <a:rPr lang="en-US" sz="14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4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orientalis</a:t>
            </a:r>
            <a:r>
              <a:rPr lang="en-US" sz="1400" i="1" kern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4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are measured as percent inhibition and expressed as mean ± SE (n=3). For total antioxidant and scavenging activities, 20-100 µg ml</a:t>
            </a:r>
            <a:r>
              <a:rPr lang="en-US" sz="1400" baseline="300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-1</a:t>
            </a:r>
            <a:r>
              <a:rPr lang="en-US" sz="14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dose, while for reducing capacity, 10-50 µg ml</a:t>
            </a:r>
            <a:r>
              <a:rPr lang="en-US" sz="1400" baseline="300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-1</a:t>
            </a:r>
            <a:r>
              <a:rPr lang="en-US" sz="14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dose used. (A) Different activities, (B) Different dose applied</a:t>
            </a:r>
            <a:endParaRPr lang="en-I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64232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F80B217B-F63C-47C0-A582-6E26F090B58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7171602"/>
              </p:ext>
            </p:extLst>
          </p:nvPr>
        </p:nvGraphicFramePr>
        <p:xfrm>
          <a:off x="3374118" y="1409700"/>
          <a:ext cx="3657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9501F303-885F-45C6-A9CF-A6AC754A19FE}"/>
              </a:ext>
            </a:extLst>
          </p:cNvPr>
          <p:cNvSpPr txBox="1"/>
          <p:nvPr/>
        </p:nvSpPr>
        <p:spPr>
          <a:xfrm>
            <a:off x="3505200" y="4152900"/>
            <a:ext cx="3733801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1800"/>
              </a:spcBef>
              <a:spcAft>
                <a:spcPts val="0"/>
              </a:spcAft>
              <a:tabLst>
                <a:tab pos="900430" algn="l"/>
              </a:tabLst>
            </a:pPr>
            <a:r>
              <a:rPr lang="en-US" sz="1400" b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Figure S2:</a:t>
            </a:r>
            <a:r>
              <a:rPr lang="en-US" sz="14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ROS inhibitory activity of </a:t>
            </a:r>
            <a:r>
              <a:rPr lang="en-US" sz="1400" b="1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Acrosiphonia</a:t>
            </a:r>
            <a:r>
              <a:rPr lang="en-US" sz="1400" b="1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400" b="1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orientalis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.</a:t>
            </a:r>
            <a:r>
              <a:rPr lang="en-US" sz="14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 Activity is shown as percent radical inhibition in the cell lines treated with EC</a:t>
            </a:r>
            <a:r>
              <a:rPr lang="en-US" sz="1400" baseline="-250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50</a:t>
            </a:r>
            <a:r>
              <a:rPr lang="en-US" sz="14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 dose of </a:t>
            </a:r>
            <a:r>
              <a:rPr lang="en-US" sz="14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Acrosiphonia</a:t>
            </a:r>
            <a:r>
              <a:rPr lang="en-US" sz="14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4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orientalis</a:t>
            </a:r>
            <a:r>
              <a:rPr lang="en-US" sz="14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4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extract</a:t>
            </a:r>
            <a:r>
              <a:rPr lang="en-US" sz="14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. Data are expressed as mean ± standard error of the mean (SE; n=3)</a:t>
            </a:r>
            <a:endParaRPr lang="en-IN" sz="1400" dirty="0">
              <a:effectLst/>
              <a:latin typeface="Cambria" panose="02040503050406030204" pitchFamily="18" charset="0"/>
              <a:ea typeface="MS Mincho" panose="02020609040205080304" pitchFamily="49" charset="-128"/>
              <a:cs typeface="Mangal" panose="00000400000000000000" pitchFamily="2"/>
            </a:endParaRPr>
          </a:p>
        </p:txBody>
      </p:sp>
    </p:spTree>
    <p:extLst>
      <p:ext uri="{BB962C8B-B14F-4D97-AF65-F5344CB8AC3E}">
        <p14:creationId xmlns:p14="http://schemas.microsoft.com/office/powerpoint/2010/main" val="11443052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EED7381-D0FD-4D11-9509-59577A9ADFD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22" b="6666"/>
          <a:stretch/>
        </p:blipFill>
        <p:spPr>
          <a:xfrm>
            <a:off x="6362700" y="76200"/>
            <a:ext cx="4492510" cy="62484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A4151D1-36A5-4DC0-90E0-996AE5F9D4A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22" b="6666"/>
          <a:stretch/>
        </p:blipFill>
        <p:spPr>
          <a:xfrm>
            <a:off x="2136890" y="76200"/>
            <a:ext cx="4492510" cy="6248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68C42BD-4FBB-4D16-8682-13D42AB3785A}"/>
              </a:ext>
            </a:extLst>
          </p:cNvPr>
          <p:cNvSpPr txBox="1"/>
          <p:nvPr/>
        </p:nvSpPr>
        <p:spPr>
          <a:xfrm>
            <a:off x="2136890" y="6286500"/>
            <a:ext cx="871832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1800"/>
              </a:spcBef>
              <a:tabLst>
                <a:tab pos="900430" algn="l"/>
              </a:tabLst>
            </a:pPr>
            <a:r>
              <a:rPr lang="en-US" sz="1400" b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Figure S3:</a:t>
            </a:r>
            <a:r>
              <a:rPr lang="en-US" sz="14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Scattered and volcano plots showing </a:t>
            </a:r>
            <a:r>
              <a:rPr lang="en-US" sz="1400" b="1" dirty="0"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differentially expressed genes. </a:t>
            </a:r>
            <a:r>
              <a:rPr lang="en-US" sz="1400" dirty="0"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Plots showing genes </a:t>
            </a:r>
            <a:r>
              <a:rPr lang="en-US" sz="14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up or down regulated (&lt;–2 or &gt;2) in Huh-7 cells treated with EC</a:t>
            </a:r>
            <a:r>
              <a:rPr lang="en-US" sz="1400" baseline="-250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50</a:t>
            </a:r>
            <a:r>
              <a:rPr lang="en-US" sz="14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 dose of </a:t>
            </a:r>
            <a:r>
              <a:rPr lang="en-US" sz="14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A. </a:t>
            </a:r>
            <a:r>
              <a:rPr lang="en-US" sz="14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orientalis</a:t>
            </a:r>
            <a:r>
              <a:rPr lang="en-US" sz="14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4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ompared to untreated (control) cells </a:t>
            </a:r>
            <a:endParaRPr lang="en-IN" sz="1400" dirty="0">
              <a:effectLst/>
              <a:latin typeface="Cambria" panose="02040503050406030204" pitchFamily="18" charset="0"/>
              <a:ea typeface="MS Mincho" panose="02020609040205080304" pitchFamily="49" charset="-128"/>
              <a:cs typeface="Mangal" panose="00000400000000000000" pitchFamily="2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BF80B35-949A-45C4-94C1-40ABF4C2A718}"/>
              </a:ext>
            </a:extLst>
          </p:cNvPr>
          <p:cNvSpPr txBox="1"/>
          <p:nvPr/>
        </p:nvSpPr>
        <p:spPr>
          <a:xfrm>
            <a:off x="1181100" y="8792"/>
            <a:ext cx="63973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Scattered Plot                                                                                              Volcano Plot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0830842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D31C0E80-31A9-4308-8974-E3EEC54ED900}"/>
              </a:ext>
            </a:extLst>
          </p:cNvPr>
          <p:cNvGrpSpPr/>
          <p:nvPr/>
        </p:nvGrpSpPr>
        <p:grpSpPr>
          <a:xfrm>
            <a:off x="2825604" y="907833"/>
            <a:ext cx="6543723" cy="4386461"/>
            <a:chOff x="2825604" y="5834"/>
            <a:chExt cx="6543723" cy="4386461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CE827D78-C843-4418-96E2-DF884CE8740B}"/>
                </a:ext>
              </a:extLst>
            </p:cNvPr>
            <p:cNvGrpSpPr/>
            <p:nvPr/>
          </p:nvGrpSpPr>
          <p:grpSpPr>
            <a:xfrm>
              <a:off x="2828192" y="190500"/>
              <a:ext cx="6541135" cy="4201795"/>
              <a:chOff x="153035" y="228600"/>
              <a:chExt cx="6541135" cy="4201795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041CEB55-EF72-44EA-99B2-E7637B8EDF2C}"/>
                  </a:ext>
                </a:extLst>
              </p:cNvPr>
              <p:cNvPicPr/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186"/>
              <a:stretch/>
            </p:blipFill>
            <p:spPr bwMode="auto">
              <a:xfrm>
                <a:off x="342900" y="228600"/>
                <a:ext cx="3098409" cy="1915160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E5411F9A-7844-4CFF-8663-D109CAEB9D33}"/>
                  </a:ext>
                </a:extLst>
              </p:cNvPr>
              <p:cNvPicPr/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807"/>
              <a:stretch/>
            </p:blipFill>
            <p:spPr bwMode="auto">
              <a:xfrm>
                <a:off x="3581400" y="228600"/>
                <a:ext cx="3112770" cy="1915160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D5B7C9D3-876A-4657-9B28-4FE735BC52B8}"/>
                  </a:ext>
                </a:extLst>
              </p:cNvPr>
              <p:cNvPicPr/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3035" y="2705100"/>
                <a:ext cx="2933065" cy="1725295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6D2F5A9D-198A-46C5-8D87-4BE21055A2C3}"/>
                  </a:ext>
                </a:extLst>
              </p:cNvPr>
              <p:cNvPicPr/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162935" y="2705099"/>
                <a:ext cx="2933065" cy="1725295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A02E9D8-7DC2-493A-AA54-F9CE5E0F871D}"/>
                </a:ext>
              </a:extLst>
            </p:cNvPr>
            <p:cNvSpPr txBox="1"/>
            <p:nvPr/>
          </p:nvSpPr>
          <p:spPr>
            <a:xfrm>
              <a:off x="2825604" y="5834"/>
              <a:ext cx="3679212" cy="28623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                                                      B</a:t>
              </a:r>
            </a:p>
            <a:p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                                                      D</a:t>
              </a:r>
              <a:endParaRPr lang="en-IN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5877E248-5DE3-4F0E-A4C4-D72898DD0AAF}"/>
              </a:ext>
            </a:extLst>
          </p:cNvPr>
          <p:cNvSpPr txBox="1"/>
          <p:nvPr/>
        </p:nvSpPr>
        <p:spPr>
          <a:xfrm>
            <a:off x="2514600" y="5294293"/>
            <a:ext cx="7239000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1800"/>
              </a:spcBef>
              <a:tabLst>
                <a:tab pos="900430" algn="l"/>
              </a:tabLst>
            </a:pPr>
            <a:r>
              <a:rPr lang="en-US" sz="1400" b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Figure S4: Differentially expressed genes in Huh-7 cells. </a:t>
            </a:r>
            <a:r>
              <a:rPr lang="en-US" sz="14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Microarray analysis showed total number of genes (A) up-regulated, (B) down-regulated,</a:t>
            </a:r>
            <a:r>
              <a:rPr lang="en-US" sz="14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number of (C) coding genes and (D) non-coding genes differentially expressed (</a:t>
            </a:r>
            <a:r>
              <a:rPr lang="en-US" sz="14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up or down regulated; &lt;–2 or &gt;2) in Huh-7 cells treated with EC</a:t>
            </a:r>
            <a:r>
              <a:rPr lang="en-US" sz="1400" baseline="-250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50</a:t>
            </a:r>
            <a:r>
              <a:rPr lang="en-US" sz="14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 dose of </a:t>
            </a:r>
            <a:r>
              <a:rPr lang="en-US" sz="14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Acrosiphonia</a:t>
            </a:r>
            <a:r>
              <a:rPr lang="en-US" sz="14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 </a:t>
            </a:r>
            <a:r>
              <a:rPr lang="en-US" sz="14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orientalis</a:t>
            </a:r>
            <a:r>
              <a:rPr lang="en-US" sz="14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 </a:t>
            </a:r>
            <a:r>
              <a:rPr lang="en-US" sz="14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ompared to untreated (control) cells</a:t>
            </a:r>
            <a:endParaRPr lang="en-IN" sz="1400" dirty="0">
              <a:effectLst/>
              <a:latin typeface="Cambria" panose="02040503050406030204" pitchFamily="18" charset="0"/>
              <a:ea typeface="MS Mincho" panose="02020609040205080304" pitchFamily="49" charset="-128"/>
              <a:cs typeface="Mangal" panose="00000400000000000000" pitchFamily="2"/>
            </a:endParaRPr>
          </a:p>
        </p:txBody>
      </p:sp>
    </p:spTree>
    <p:extLst>
      <p:ext uri="{BB962C8B-B14F-4D97-AF65-F5344CB8AC3E}">
        <p14:creationId xmlns:p14="http://schemas.microsoft.com/office/powerpoint/2010/main" val="28603369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31FD5D4A-E3C9-463E-B5A1-23DB0D3E1D7F}"/>
              </a:ext>
            </a:extLst>
          </p:cNvPr>
          <p:cNvGrpSpPr>
            <a:grpSpLocks noChangeAspect="1"/>
          </p:cNvGrpSpPr>
          <p:nvPr/>
        </p:nvGrpSpPr>
        <p:grpSpPr>
          <a:xfrm>
            <a:off x="2400300" y="76201"/>
            <a:ext cx="7406640" cy="6509361"/>
            <a:chOff x="2200989" y="76200"/>
            <a:chExt cx="7673282" cy="6743700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E2CF2170-C4AC-45E5-B908-DF57D539C6E4}"/>
                </a:ext>
              </a:extLst>
            </p:cNvPr>
            <p:cNvGrpSpPr/>
            <p:nvPr/>
          </p:nvGrpSpPr>
          <p:grpSpPr>
            <a:xfrm>
              <a:off x="2247900" y="76200"/>
              <a:ext cx="7626371" cy="6743700"/>
              <a:chOff x="2247900" y="76200"/>
              <a:chExt cx="7626371" cy="6743700"/>
            </a:xfrm>
          </p:grpSpPr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BBB8A64E-36BC-4C3D-AE45-4B3AD0B547D8}"/>
                  </a:ext>
                </a:extLst>
              </p:cNvPr>
              <p:cNvGrpSpPr/>
              <p:nvPr/>
            </p:nvGrpSpPr>
            <p:grpSpPr>
              <a:xfrm>
                <a:off x="2400300" y="120162"/>
                <a:ext cx="7473971" cy="6689782"/>
                <a:chOff x="2400300" y="120162"/>
                <a:chExt cx="7473971" cy="6689782"/>
              </a:xfrm>
            </p:grpSpPr>
            <p:pic>
              <p:nvPicPr>
                <p:cNvPr id="10" name="Picture 9">
                  <a:extLst>
                    <a:ext uri="{FF2B5EF4-FFF2-40B4-BE49-F238E27FC236}">
                      <a16:creationId xmlns:a16="http://schemas.microsoft.com/office/drawing/2014/main" id="{B8B87A85-02FC-4009-A302-7C92A908BCD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b="1112"/>
                <a:stretch/>
              </p:blipFill>
              <p:spPr>
                <a:xfrm>
                  <a:off x="2400300" y="120162"/>
                  <a:ext cx="7406640" cy="6689782"/>
                </a:xfrm>
                <a:prstGeom prst="rect">
                  <a:avLst/>
                </a:prstGeom>
              </p:spPr>
            </p:pic>
            <p:grpSp>
              <p:nvGrpSpPr>
                <p:cNvPr id="13" name="Group 12">
                  <a:extLst>
                    <a:ext uri="{FF2B5EF4-FFF2-40B4-BE49-F238E27FC236}">
                      <a16:creationId xmlns:a16="http://schemas.microsoft.com/office/drawing/2014/main" id="{CEB0A9F2-C0B0-4DFD-89FC-421ECF250767}"/>
                    </a:ext>
                  </a:extLst>
                </p:cNvPr>
                <p:cNvGrpSpPr/>
                <p:nvPr/>
              </p:nvGrpSpPr>
              <p:grpSpPr>
                <a:xfrm>
                  <a:off x="9340150" y="5076092"/>
                  <a:ext cx="534121" cy="1461939"/>
                  <a:chOff x="6939850" y="5533292"/>
                  <a:chExt cx="534121" cy="1461939"/>
                </a:xfrm>
              </p:grpSpPr>
              <p:sp>
                <p:nvSpPr>
                  <p:cNvPr id="11" name="Rectangle 10">
                    <a:extLst>
                      <a:ext uri="{FF2B5EF4-FFF2-40B4-BE49-F238E27FC236}">
                        <a16:creationId xmlns:a16="http://schemas.microsoft.com/office/drawing/2014/main" id="{45905B4E-DC5D-4B81-972B-5C86247BBE44}"/>
                      </a:ext>
                    </a:extLst>
                  </p:cNvPr>
                  <p:cNvSpPr/>
                  <p:nvPr/>
                </p:nvSpPr>
                <p:spPr>
                  <a:xfrm>
                    <a:off x="7162800" y="5739944"/>
                    <a:ext cx="91440" cy="914400"/>
                  </a:xfrm>
                  <a:prstGeom prst="rect">
                    <a:avLst/>
                  </a:prstGeom>
                  <a:gradFill flip="none" rotWithShape="1">
                    <a:gsLst>
                      <a:gs pos="0">
                        <a:srgbClr val="C00000"/>
                      </a:gs>
                      <a:gs pos="70000">
                        <a:schemeClr val="accent6">
                          <a:lumMod val="50000"/>
                        </a:schemeClr>
                      </a:gs>
                    </a:gsLst>
                    <a:lin ang="5400000" scaled="1"/>
                    <a:tileRect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sp>
                <p:nvSpPr>
                  <p:cNvPr id="12" name="TextBox 11">
                    <a:extLst>
                      <a:ext uri="{FF2B5EF4-FFF2-40B4-BE49-F238E27FC236}">
                        <a16:creationId xmlns:a16="http://schemas.microsoft.com/office/drawing/2014/main" id="{F53967FC-A8B6-4368-8AD3-E425CFEE39AA}"/>
                      </a:ext>
                    </a:extLst>
                  </p:cNvPr>
                  <p:cNvSpPr txBox="1"/>
                  <p:nvPr/>
                </p:nvSpPr>
                <p:spPr>
                  <a:xfrm>
                    <a:off x="6939850" y="5533292"/>
                    <a:ext cx="534121" cy="146193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up (2)</a:t>
                    </a:r>
                  </a:p>
                  <a:p>
                    <a:pPr algn="ctr"/>
                    <a:endParaRPr lang="en-IN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endParaRPr lang="en-IN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endParaRPr lang="en-IN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endParaRPr lang="en-IN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endParaRPr lang="en-IN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r>
                      <a:rPr lang="en-IN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own </a:t>
                    </a:r>
                  </a:p>
                  <a:p>
                    <a:pPr algn="ctr"/>
                    <a:r>
                      <a:rPr lang="en-IN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(-2)</a:t>
                    </a:r>
                  </a:p>
                </p:txBody>
              </p:sp>
            </p:grpSp>
          </p:grpSp>
          <p:sp>
            <p:nvSpPr>
              <p:cNvPr id="2" name="Rectangle: Rounded Corners 1">
                <a:extLst>
                  <a:ext uri="{FF2B5EF4-FFF2-40B4-BE49-F238E27FC236}">
                    <a16:creationId xmlns:a16="http://schemas.microsoft.com/office/drawing/2014/main" id="{87B5E84A-23C4-4ADF-9D18-AC70FDA6873B}"/>
                  </a:ext>
                </a:extLst>
              </p:cNvPr>
              <p:cNvSpPr/>
              <p:nvPr/>
            </p:nvSpPr>
            <p:spPr>
              <a:xfrm>
                <a:off x="2247900" y="76200"/>
                <a:ext cx="7543800" cy="6743700"/>
              </a:xfrm>
              <a:prstGeom prst="roundRect">
                <a:avLst>
                  <a:gd name="adj" fmla="val 1152"/>
                </a:avLst>
              </a:prstGeom>
              <a:noFill/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6894CF2-779F-4F3B-9B8E-417D9D82B9D6}"/>
                </a:ext>
              </a:extLst>
            </p:cNvPr>
            <p:cNvSpPr txBox="1"/>
            <p:nvPr/>
          </p:nvSpPr>
          <p:spPr>
            <a:xfrm rot="16200000">
              <a:off x="1649075" y="3333215"/>
              <a:ext cx="13500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romosome numbers</a:t>
              </a:r>
              <a:endParaRPr lang="en-IN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39EEF145-0035-4258-8700-30D4ADAC5F77}"/>
                </a:ext>
              </a:extLst>
            </p:cNvPr>
            <p:cNvSpPr txBox="1"/>
            <p:nvPr/>
          </p:nvSpPr>
          <p:spPr>
            <a:xfrm rot="16200000">
              <a:off x="8962963" y="5613882"/>
              <a:ext cx="10005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ld expression</a:t>
              </a:r>
              <a:endParaRPr lang="en-IN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DB5D0391-96CB-4337-8A78-34D9A9CBB54B}"/>
              </a:ext>
            </a:extLst>
          </p:cNvPr>
          <p:cNvSpPr txBox="1"/>
          <p:nvPr/>
        </p:nvSpPr>
        <p:spPr>
          <a:xfrm>
            <a:off x="1485900" y="6581001"/>
            <a:ext cx="94107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1800"/>
              </a:spcBef>
              <a:tabLst>
                <a:tab pos="900430" algn="l"/>
              </a:tabLst>
            </a:pPr>
            <a:r>
              <a:rPr lang="en-US" sz="1200" b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Figure S5: Differentially expressed genes in Huh-7 cells. </a:t>
            </a:r>
            <a:r>
              <a:rPr lang="en-US" sz="11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Microarray analysis showed differentially expressed genes are distributed across the chromosomes.</a:t>
            </a:r>
            <a:endParaRPr lang="en-IN" sz="1100" dirty="0">
              <a:effectLst/>
              <a:latin typeface="Cambria" panose="02040503050406030204" pitchFamily="18" charset="0"/>
              <a:ea typeface="MS Mincho" panose="02020609040205080304" pitchFamily="49" charset="-128"/>
              <a:cs typeface="Mangal" panose="00000400000000000000" pitchFamily="2"/>
            </a:endParaRPr>
          </a:p>
        </p:txBody>
      </p:sp>
    </p:spTree>
    <p:extLst>
      <p:ext uri="{BB962C8B-B14F-4D97-AF65-F5344CB8AC3E}">
        <p14:creationId xmlns:p14="http://schemas.microsoft.com/office/powerpoint/2010/main" val="13691476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9567799E-4F2C-45D0-81CA-D7B19D9D717C}"/>
              </a:ext>
            </a:extLst>
          </p:cNvPr>
          <p:cNvSpPr txBox="1"/>
          <p:nvPr/>
        </p:nvSpPr>
        <p:spPr>
          <a:xfrm>
            <a:off x="3229487" y="6564877"/>
            <a:ext cx="55245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1800"/>
              </a:spcBef>
              <a:tabLst>
                <a:tab pos="900430" algn="l"/>
              </a:tabLst>
            </a:pPr>
            <a:r>
              <a:rPr lang="en-US" sz="1400" b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Mangal" panose="00000400000000000000" pitchFamily="2"/>
              </a:rPr>
              <a:t>Figure S6: Differentially expressed genes showing exon splicing index </a:t>
            </a:r>
            <a:endParaRPr lang="en-IN" sz="1400" dirty="0">
              <a:effectLst/>
              <a:latin typeface="Cambria" panose="02040503050406030204" pitchFamily="18" charset="0"/>
              <a:ea typeface="MS Mincho" panose="02020609040205080304" pitchFamily="49" charset="-128"/>
              <a:cs typeface="Mangal" panose="00000400000000000000" pitchFamily="2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EBFEFED-602F-44FD-8F4E-42F5A0164AF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66" b="63651"/>
          <a:stretch/>
        </p:blipFill>
        <p:spPr>
          <a:xfrm>
            <a:off x="1203960" y="114300"/>
            <a:ext cx="9784080" cy="369790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93FA2F5-0700-46AB-B961-C670C113A6C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0" b="5732"/>
          <a:stretch/>
        </p:blipFill>
        <p:spPr bwMode="auto">
          <a:xfrm>
            <a:off x="3095065" y="4119284"/>
            <a:ext cx="6007103" cy="22860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6270955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263</TotalTime>
  <Words>308</Words>
  <Application>Microsoft Office PowerPoint</Application>
  <PresentationFormat>Widescreen</PresentationFormat>
  <Paragraphs>4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Cambria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SIR-CSMCR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vinash Mishra</dc:creator>
  <cp:lastModifiedBy>Avinash Mishra</cp:lastModifiedBy>
  <cp:revision>89</cp:revision>
  <dcterms:created xsi:type="dcterms:W3CDTF">2022-02-01T05:12:10Z</dcterms:created>
  <dcterms:modified xsi:type="dcterms:W3CDTF">2023-04-21T10:00:12Z</dcterms:modified>
</cp:coreProperties>
</file>